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A088C6-0BA7-4E9F-8C5B-1D043672BC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830D368-B481-4EA7-815A-AA9F77EC97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68FD73-7C94-404F-A099-D8F64CA36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750F51-A1AE-495A-BA75-237177A64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21F9FA-77F6-4836-BAD9-8B0EAB21F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068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EDCB04-EE32-4D7F-A08C-EBC02D39B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3B1C5A-95B0-44FF-A26A-CB219D6853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0065B9-EBA4-4910-8C33-109CE18A1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C3D7EB-2629-43AA-9F62-BDB911AC9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42E438-A191-4795-9D39-95A06217A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74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5FC792-1305-497F-AADC-31E0DD173B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4C0128-D1BB-4481-89A0-C56D019542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90C3E4-2F5D-4463-BF89-12ED2BD86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E79D68-227F-4EC6-B20C-DC18AE697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F7769D-12E9-4A7E-8999-66FA7F45F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437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6F3AB-A8F9-4A49-B8FB-308A1DAE7D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88CA88-E340-4C8F-B89A-F9043203BA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BB85F-50DF-4476-8FB8-3E1CF6DFC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E2968B-5BA6-4823-B3D8-2763D7A2F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C18369-B577-498A-952B-04E3C99B7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9019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C7DBF3-D70D-4997-8A9F-2B4AEE084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FFCDE5-AE25-4E3F-B870-ECA6936A1F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60979F-D211-41F1-88C1-36EF10C78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D1A53D-ACD8-4253-8577-9FB98A3B9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3798B7-6645-4EB7-A852-B921A7993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1495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9CBBC9-03E9-44AF-B67C-1659BC32A4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45E736-C59A-4DDF-9E82-0F9921D713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89821C-3400-4725-9074-3325F50BEB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FDB75B-9AA8-47CB-9467-E39553790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A8C563-48FD-435E-A877-F2935FC0B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13334A-7803-43B8-98F7-E84633B78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9646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AEC93-5AC1-4E3C-BA68-C046A9B33B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E0D948-24D5-4058-B434-8113EE69D8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73E32A-BB0B-46DF-A9BF-4099340C57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FB2C55-FAC1-456F-B20B-2092CB24D2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BD6C42-D362-4357-B819-763491A13C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034C5B-DBA5-48F2-BA75-16417F571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0A531B-4C71-4C35-9295-E8F2849A4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01EEDC-F0C5-4B52-A203-8625F9130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0874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A28BA-8796-4AE6-A18A-7018916B2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8501AB-6FD3-49AC-9D24-CC5124C87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98B9F0-0254-4711-8798-D831DA747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5F91F5-9E37-4F87-ABE9-23AC6B33B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0300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CBDFD5-F905-4C4F-99BA-924250884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5E0A5F-EF9C-474A-BCDA-4DE0F832F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23818D-E566-4FA9-88DE-E0543E567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717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AF6667-533F-4597-A2A9-601B97F95A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724825-B8A6-4D10-9404-7AE2F6001D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E89435-EF02-4A09-84EF-BD2CD7A965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8BAAD0-3A93-427A-A932-F14F3E2EB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27201E-1C9D-4A59-B40E-5A4B8BC9C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ED825B-3842-4713-9351-4D9E87BB5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3692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6E0F28-B3A8-4361-9E7C-D213465D5E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13DF74-FCDF-45F4-AE83-F2EEDEB5F8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2D4F4D-F88F-4656-933A-6FD453E710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FEE020-05DA-49CE-8247-A17A55843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475194-B712-4312-9134-371FFE881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B76ACD-ED9B-49F4-997A-9414D3967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0231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01E796-FDA0-44B3-B8B1-B01B621956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A210C2-9673-4360-BBE8-03BBB83C9B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2DC64-453B-419B-9CC4-01AABD0DD2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6F10EE-1CDB-4CBE-887F-CA63B39323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A293AC-F428-4A11-ADA2-E5C75F170A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1520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>
            <a:extLst>
              <a:ext uri="{FF2B5EF4-FFF2-40B4-BE49-F238E27FC236}">
                <a16:creationId xmlns:a16="http://schemas.microsoft.com/office/drawing/2014/main" id="{AE78DDAE-4D3C-47A7-8C17-06860C8B6EAD}"/>
              </a:ext>
            </a:extLst>
          </p:cNvPr>
          <p:cNvGrpSpPr/>
          <p:nvPr/>
        </p:nvGrpSpPr>
        <p:grpSpPr>
          <a:xfrm>
            <a:off x="1416360" y="1120725"/>
            <a:ext cx="9876565" cy="4891951"/>
            <a:chOff x="1253800" y="236805"/>
            <a:chExt cx="9876565" cy="4891951"/>
          </a:xfrm>
        </p:grpSpPr>
        <p:pic>
          <p:nvPicPr>
            <p:cNvPr id="3" name="Picture 2" descr="A picture containing drawing&#10;&#10;Description automatically generated">
              <a:extLst>
                <a:ext uri="{FF2B5EF4-FFF2-40B4-BE49-F238E27FC236}">
                  <a16:creationId xmlns:a16="http://schemas.microsoft.com/office/drawing/2014/main" id="{6EC29B0B-616D-40F9-8B69-696FE991B16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36412" y="237967"/>
              <a:ext cx="4507200" cy="11772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6EA9C41-ACE5-4F1A-BADD-C26CD440448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5348" y="236805"/>
              <a:ext cx="4505652" cy="1178362"/>
            </a:xfrm>
            <a:prstGeom prst="rect">
              <a:avLst/>
            </a:prstGeom>
          </p:spPr>
        </p:pic>
        <p:pic>
          <p:nvPicPr>
            <p:cNvPr id="6" name="Picture 5" descr="A picture containing drawing&#10;&#10;Description automatically generated">
              <a:extLst>
                <a:ext uri="{FF2B5EF4-FFF2-40B4-BE49-F238E27FC236}">
                  <a16:creationId xmlns:a16="http://schemas.microsoft.com/office/drawing/2014/main" id="{BF08A569-D43A-4AC8-A896-E7652ABE273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46773" y="3271533"/>
              <a:ext cx="4507200" cy="1177200"/>
            </a:xfrm>
            <a:prstGeom prst="rect">
              <a:avLst/>
            </a:prstGeom>
          </p:spPr>
        </p:pic>
        <p:pic>
          <p:nvPicPr>
            <p:cNvPr id="17" name="Picture 16" descr="A picture containing drawing&#10;&#10;Description automatically generated">
              <a:extLst>
                <a:ext uri="{FF2B5EF4-FFF2-40B4-BE49-F238E27FC236}">
                  <a16:creationId xmlns:a16="http://schemas.microsoft.com/office/drawing/2014/main" id="{6B8DD4EA-C41F-4018-AE6B-E2629D7241CB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37959" y="1257951"/>
              <a:ext cx="4505653" cy="1180800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178E73E-E7DF-4993-844B-7A9EAC892BA4}"/>
                </a:ext>
              </a:extLst>
            </p:cNvPr>
            <p:cNvSpPr txBox="1"/>
            <p:nvPr/>
          </p:nvSpPr>
          <p:spPr>
            <a:xfrm>
              <a:off x="6501808" y="4401545"/>
              <a:ext cx="46285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EH         CH       KE      MF          WF      PGC        MHS        BC    BH  CC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373320E2-9840-4CC4-8087-7D133DFEE5BC}"/>
                </a:ext>
              </a:extLst>
            </p:cNvPr>
            <p:cNvSpPr/>
            <p:nvPr/>
          </p:nvSpPr>
          <p:spPr>
            <a:xfrm>
              <a:off x="1929131" y="4256389"/>
              <a:ext cx="3906237" cy="17245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EE43812-DD20-41BB-8C4A-C35F1D43A233}"/>
                </a:ext>
              </a:extLst>
            </p:cNvPr>
            <p:cNvSpPr txBox="1"/>
            <p:nvPr/>
          </p:nvSpPr>
          <p:spPr>
            <a:xfrm>
              <a:off x="2976880" y="4759424"/>
              <a:ext cx="1473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With locprior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F93E775-0803-426E-A93D-8C3E6E69A0B1}"/>
                </a:ext>
              </a:extLst>
            </p:cNvPr>
            <p:cNvSpPr txBox="1"/>
            <p:nvPr/>
          </p:nvSpPr>
          <p:spPr>
            <a:xfrm>
              <a:off x="7376162" y="4759424"/>
              <a:ext cx="18389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Without locprior</a:t>
              </a:r>
            </a:p>
          </p:txBody>
        </p:sp>
        <p:pic>
          <p:nvPicPr>
            <p:cNvPr id="32" name="Picture 31" descr="A picture containing drawing&#10;&#10;Description automatically generated">
              <a:extLst>
                <a:ext uri="{FF2B5EF4-FFF2-40B4-BE49-F238E27FC236}">
                  <a16:creationId xmlns:a16="http://schemas.microsoft.com/office/drawing/2014/main" id="{6F7E64E1-A6FA-42F2-9BC7-93B33D08E563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3801" y="1261551"/>
              <a:ext cx="4507200" cy="1177200"/>
            </a:xfrm>
            <a:prstGeom prst="rect">
              <a:avLst/>
            </a:prstGeom>
          </p:spPr>
        </p:pic>
        <p:pic>
          <p:nvPicPr>
            <p:cNvPr id="34" name="Picture 33" descr="A drawing of a cartoon character&#10;&#10;Description automatically generated">
              <a:extLst>
                <a:ext uri="{FF2B5EF4-FFF2-40B4-BE49-F238E27FC236}">
                  <a16:creationId xmlns:a16="http://schemas.microsoft.com/office/drawing/2014/main" id="{DE2328C4-F803-4AAB-B72A-0891BCB406F3}"/>
                </a:ext>
              </a:extLst>
            </p:cNvPr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3800" y="2272047"/>
              <a:ext cx="4507200" cy="11772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D76DB812-C75A-41B6-BBCB-1A95D632821B}"/>
                </a:ext>
              </a:extLst>
            </p:cNvPr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3800" y="3273751"/>
              <a:ext cx="4507200" cy="1177200"/>
            </a:xfrm>
            <a:prstGeom prst="rect">
              <a:avLst/>
            </a:prstGeom>
          </p:spPr>
        </p:pic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886833B5-F542-4346-A27E-FEA73AFDC0E0}"/>
                </a:ext>
              </a:extLst>
            </p:cNvPr>
            <p:cNvSpPr/>
            <p:nvPr/>
          </p:nvSpPr>
          <p:spPr>
            <a:xfrm>
              <a:off x="1554281" y="4299516"/>
              <a:ext cx="3906237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6DF8515-CEAC-41E9-A78E-50DA6E1E8AEE}"/>
                </a:ext>
              </a:extLst>
            </p:cNvPr>
            <p:cNvSpPr txBox="1"/>
            <p:nvPr/>
          </p:nvSpPr>
          <p:spPr>
            <a:xfrm>
              <a:off x="1467443" y="4426860"/>
              <a:ext cx="46285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EH         CH       KE       MF           WF          PGC        MHS       BC    BH  CC</a:t>
              </a:r>
            </a:p>
          </p:txBody>
        </p:sp>
        <p:pic>
          <p:nvPicPr>
            <p:cNvPr id="40" name="Picture 39" descr="A picture containing drawing&#10;&#10;Description automatically generated">
              <a:extLst>
                <a:ext uri="{FF2B5EF4-FFF2-40B4-BE49-F238E27FC236}">
                  <a16:creationId xmlns:a16="http://schemas.microsoft.com/office/drawing/2014/main" id="{892A8A7B-D128-46A3-BB6C-084259364804}"/>
                </a:ext>
              </a:extLst>
            </p:cNvPr>
            <p:cNvPicPr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36412" y="2267651"/>
              <a:ext cx="4507200" cy="1177200"/>
            </a:xfrm>
            <a:prstGeom prst="rect">
              <a:avLst/>
            </a:prstGeom>
          </p:spPr>
        </p:pic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10BB7517-9524-4C92-BB5D-7AFE9D460640}"/>
                </a:ext>
              </a:extLst>
            </p:cNvPr>
            <p:cNvSpPr/>
            <p:nvPr/>
          </p:nvSpPr>
          <p:spPr>
            <a:xfrm>
              <a:off x="5405640" y="283938"/>
              <a:ext cx="222413" cy="407196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1C6889C7-E849-420B-93BC-AF6F9D3F0A08}"/>
                </a:ext>
              </a:extLst>
            </p:cNvPr>
            <p:cNvSpPr/>
            <p:nvPr/>
          </p:nvSpPr>
          <p:spPr>
            <a:xfrm>
              <a:off x="10373426" y="354892"/>
              <a:ext cx="222413" cy="407196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E99F60E-45B0-47E9-B730-6DBF3C37FB04}"/>
                </a:ext>
              </a:extLst>
            </p:cNvPr>
            <p:cNvSpPr txBox="1"/>
            <p:nvPr/>
          </p:nvSpPr>
          <p:spPr>
            <a:xfrm>
              <a:off x="5621429" y="3782244"/>
              <a:ext cx="6475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K=6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79C39D2-C670-4AC1-9608-E5095EFD8ACD}"/>
                </a:ext>
              </a:extLst>
            </p:cNvPr>
            <p:cNvSpPr txBox="1"/>
            <p:nvPr/>
          </p:nvSpPr>
          <p:spPr>
            <a:xfrm>
              <a:off x="5621429" y="782810"/>
              <a:ext cx="6475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K=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5B86430-9BAF-4E0C-A8BB-1F37710D3CC7}"/>
                </a:ext>
              </a:extLst>
            </p:cNvPr>
            <p:cNvSpPr txBox="1"/>
            <p:nvPr/>
          </p:nvSpPr>
          <p:spPr>
            <a:xfrm>
              <a:off x="5621429" y="1754601"/>
              <a:ext cx="6475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K=4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4295600-26A3-4666-97C8-04C8B5F5F725}"/>
                </a:ext>
              </a:extLst>
            </p:cNvPr>
            <p:cNvSpPr txBox="1"/>
            <p:nvPr/>
          </p:nvSpPr>
          <p:spPr>
            <a:xfrm>
              <a:off x="5621429" y="2787826"/>
              <a:ext cx="6475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K=5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3EF92F11-2484-4659-82A4-BD8106556924}"/>
              </a:ext>
            </a:extLst>
          </p:cNvPr>
          <p:cNvSpPr txBox="1"/>
          <p:nvPr/>
        </p:nvSpPr>
        <p:spPr>
          <a:xfrm>
            <a:off x="447675" y="733425"/>
            <a:ext cx="47434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4 Figure Effect of locprior on STRUCTURE </a:t>
            </a:r>
          </a:p>
        </p:txBody>
      </p:sp>
    </p:spTree>
    <p:extLst>
      <p:ext uri="{BB962C8B-B14F-4D97-AF65-F5344CB8AC3E}">
        <p14:creationId xmlns:p14="http://schemas.microsoft.com/office/powerpoint/2010/main" val="3588112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5</TotalTime>
  <Words>43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Ball</dc:creator>
  <cp:lastModifiedBy>Sarah Ball</cp:lastModifiedBy>
  <cp:revision>10</cp:revision>
  <dcterms:created xsi:type="dcterms:W3CDTF">2019-11-20T10:51:18Z</dcterms:created>
  <dcterms:modified xsi:type="dcterms:W3CDTF">2020-03-22T17:03:15Z</dcterms:modified>
</cp:coreProperties>
</file>